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vier Gil Humanes" initials="JGH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47" autoAdjust="0"/>
    <p:restoredTop sz="93692" autoAdjust="0"/>
  </p:normalViewPr>
  <p:slideViewPr>
    <p:cSldViewPr snapToGrid="0">
      <p:cViewPr>
        <p:scale>
          <a:sx n="125" d="100"/>
          <a:sy n="125" d="100"/>
        </p:scale>
        <p:origin x="2888" y="-928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2039E6-8FFD-4632-9055-E7541BE88E6E}" type="datetimeFigureOut">
              <a:rPr lang="es-ES"/>
              <a:t>1/8/17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2A793-94D1-48B7-9FEA-506DA1E3E430}" type="slidenum">
              <a:rPr lang="es-ES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002274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12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f-target mutations detection in BW208 mutant lines. (a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f-target mutations in th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lam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encoding genes (α-gliadins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γ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gliadins,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ω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gliadins, HMW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eni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LMW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eni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 12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the seed sequence of sgAlpha-1 and sgAlpha-2 plus the NGG PAM sequence was used to search for homology in 40 HMW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eni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239 LMW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eni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179 gamma-gliadins, and 15 omega-gliadins found i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Bank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http://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ww.ncbi.nlm.nih.gov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). Up to two mismatches were allowed between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gR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genomic targets;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,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quence alignment of 16 different clones of LMW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lutenins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BW208 T1 mutant line T544;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f-target mutations in the non-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lamin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s. The 12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t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the seed sequence of sgAlpha-1 and sgAlpha-2 plus the NGG PAM sequence was used to search for homology by BLAST in the wheat genome database (http://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lants.ensembl.org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iticum_aestivum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Info/Index). No mismatches were allowed between the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gRNA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genomic targets;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d),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equence alignment of the 7 different clones of gene Traes_2AS_8FCC59363 sequenced from BW208 T1 mutant line T544;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e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quence alignment of the 9 different clones of gene Traes_2AS_D659E88E9 sequenced from BW208 T1 mutant line T544;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f),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equence alignment of 10 different clones of gene Traes_7BL_F621D9B9E sequenced from BW208 T1 mutant line T544.</a:t>
            </a:r>
            <a:endParaRPr lang="es-ES_tradnl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52A793-94D1-48B7-9FEA-506DA1E3E430}" type="slidenum">
              <a:rPr lang="es-ES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69136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045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039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39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578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026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312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078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480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033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864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161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844FD-6826-4EA9-BB03-4450247BDEF8}" type="datetimeFigureOut">
              <a:rPr lang="en-US" smtClean="0"/>
              <a:t>8/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C6981-1111-4B06-AAD9-1AF0F438C0A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213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09"/>
          <a:stretch/>
        </p:blipFill>
        <p:spPr>
          <a:xfrm>
            <a:off x="519986" y="1769274"/>
            <a:ext cx="3352060" cy="146890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95"/>
          <a:stretch/>
        </p:blipFill>
        <p:spPr>
          <a:xfrm>
            <a:off x="489280" y="6370272"/>
            <a:ext cx="3353396" cy="96540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224712" y="18763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24712" y="505506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45"/>
          <a:stretch/>
        </p:blipFill>
        <p:spPr>
          <a:xfrm>
            <a:off x="489280" y="5055064"/>
            <a:ext cx="3353396" cy="875765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24712" y="63702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94006" y="329353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95609" y="159612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1656064"/>
              </p:ext>
            </p:extLst>
          </p:nvPr>
        </p:nvGraphicFramePr>
        <p:xfrm>
          <a:off x="529603" y="320969"/>
          <a:ext cx="3691808" cy="1296488"/>
        </p:xfrm>
        <a:graphic>
          <a:graphicData uri="http://schemas.openxmlformats.org/drawingml/2006/table">
            <a:tbl>
              <a:tblPr/>
              <a:tblGrid>
                <a:gridCol w="74336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64561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972965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32986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113598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lamin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ff-target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01651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analyzed sequence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off-target hits minimal sequence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RNA+PAM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1143"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Alpha-1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Alpha-2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13598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α-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iadin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6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2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3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13598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γ-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iadin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9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113598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ω-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iadin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1359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W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enin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016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MW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tenins</a:t>
                      </a:r>
                      <a:endParaRPr lang="es-E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9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1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13598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up to one </a:t>
                      </a: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match 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 the seed sequence + perfect PAM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7781815"/>
              </p:ext>
            </p:extLst>
          </p:nvPr>
        </p:nvGraphicFramePr>
        <p:xfrm>
          <a:off x="529603" y="3461786"/>
          <a:ext cx="5324551" cy="1289004"/>
        </p:xfrm>
        <a:graphic>
          <a:graphicData uri="http://schemas.openxmlformats.org/drawingml/2006/table">
            <a:tbl>
              <a:tblPr/>
              <a:tblGrid>
                <a:gridCol w="57838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638629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17565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43691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5704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666279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771650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87229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n-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lamin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off-target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69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RNA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  <a:endParaRPr lang="es-E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off-target hit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notated gene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scription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clones sequenced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. of clones with mutations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8722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Alpha-1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es_4AL_4FF5B8837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ha-gliadin pseudo gene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8722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8722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gAlpha-2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es_4AL_4FF5B8837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pha-gliadin pseudo gene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A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8722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es_2AS_8FCC59363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zed 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8722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es_2AS_D659E88E9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ncharacterized 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87229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raes_7BL_F621D9B9E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DS box transcription factor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87229">
                <a:tc gridSpan="3"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 Perfect match seed sequence (12 </a:t>
                      </a:r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 + PAM</a:t>
                      </a: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756" marR="7756" marT="775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224712" y="7484070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541"/>
          <a:stretch/>
        </p:blipFill>
        <p:spPr>
          <a:xfrm>
            <a:off x="489281" y="7909467"/>
            <a:ext cx="3353396" cy="965592"/>
          </a:xfrm>
          <a:prstGeom prst="rect">
            <a:avLst/>
          </a:prstGeom>
        </p:spPr>
      </p:pic>
      <p:sp>
        <p:nvSpPr>
          <p:cNvPr id="2" name="Rectángulo 1"/>
          <p:cNvSpPr/>
          <p:nvPr/>
        </p:nvSpPr>
        <p:spPr>
          <a:xfrm>
            <a:off x="4773455" y="8775263"/>
            <a:ext cx="20845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>
                <a:ea typeface="Calibri" charset="0"/>
                <a:cs typeface="Times New Roman" charset="0"/>
              </a:rPr>
              <a:t>Supplementary Figure 12</a:t>
            </a:r>
            <a:r>
              <a:rPr lang="es-ES_tradnl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216220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</TotalTime>
  <Words>349</Words>
  <Application>Microsoft Macintosh PowerPoint</Application>
  <PresentationFormat>Carta (216 x 279 mm)</PresentationFormat>
  <Paragraphs>6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resentación de PowerPoint</vt:lpstr>
    </vt:vector>
  </TitlesOfParts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vier Gil Humanes</dc:creator>
  <cp:lastModifiedBy>Francisco Barro</cp:lastModifiedBy>
  <cp:revision>32</cp:revision>
  <dcterms:created xsi:type="dcterms:W3CDTF">2016-06-08T12:35:47Z</dcterms:created>
  <dcterms:modified xsi:type="dcterms:W3CDTF">2017-08-01T08:29:50Z</dcterms:modified>
</cp:coreProperties>
</file>